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ll" initials="D" lastIdx="1" clrIdx="0">
    <p:extLst>
      <p:ext uri="{19B8F6BF-5375-455C-9EA6-DF929625EA0E}">
        <p15:presenceInfo xmlns:p15="http://schemas.microsoft.com/office/powerpoint/2012/main" userId="Del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66" d="100"/>
          <a:sy n="66" d="100"/>
        </p:scale>
        <p:origin x="199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357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0424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14713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5333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6272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6771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0702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398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6533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3069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9031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F3D77-2394-4305-BBE0-3E290C37756F}" type="datetimeFigureOut">
              <a:rPr lang="en-IN" smtClean="0"/>
              <a:t>24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862D4-B61D-4CAF-B5C2-2B826DC393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16836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C3C28339-D703-45E5-88E0-6AE58C3F11BE}"/>
              </a:ext>
            </a:extLst>
          </p:cNvPr>
          <p:cNvGrpSpPr/>
          <p:nvPr/>
        </p:nvGrpSpPr>
        <p:grpSpPr>
          <a:xfrm>
            <a:off x="1364728" y="531093"/>
            <a:ext cx="4607960" cy="3239131"/>
            <a:chOff x="1364728" y="531093"/>
            <a:chExt cx="4607960" cy="3239131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82E4260-030A-4829-9E6F-19CDB0B185CD}"/>
                </a:ext>
              </a:extLst>
            </p:cNvPr>
            <p:cNvGrpSpPr/>
            <p:nvPr/>
          </p:nvGrpSpPr>
          <p:grpSpPr>
            <a:xfrm>
              <a:off x="1408376" y="2537668"/>
              <a:ext cx="2588009" cy="1062844"/>
              <a:chOff x="0" y="2049937"/>
              <a:chExt cx="3465271" cy="1496724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D6836FFE-1663-4F36-97D5-DBCD04D663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84971" y="2070064"/>
                <a:ext cx="1680300" cy="1474459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DAEB6638-03B3-4423-8741-E117BEEE09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2049937"/>
                <a:ext cx="1765654" cy="1496724"/>
              </a:xfrm>
              <a:prstGeom prst="rect">
                <a:avLst/>
              </a:prstGeom>
            </p:spPr>
          </p:pic>
        </p:grpSp>
        <p:sp>
          <p:nvSpPr>
            <p:cNvPr id="12" name="TextBox 8">
              <a:extLst>
                <a:ext uri="{FF2B5EF4-FFF2-40B4-BE49-F238E27FC236}">
                  <a16:creationId xmlns:a16="http://schemas.microsoft.com/office/drawing/2014/main" id="{9FE91538-1C86-4AF7-AA99-7B371D3F5868}"/>
                </a:ext>
              </a:extLst>
            </p:cNvPr>
            <p:cNvSpPr txBox="1"/>
            <p:nvPr/>
          </p:nvSpPr>
          <p:spPr>
            <a:xfrm>
              <a:off x="1364728" y="531093"/>
              <a:ext cx="3188139" cy="3162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en-IN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. Uterus with growing </a:t>
              </a:r>
              <a:r>
                <a:rPr lang="en-IN" sz="1200" b="1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fetuses</a:t>
              </a:r>
              <a:r>
                <a:rPr lang="en-IN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9">
              <a:extLst>
                <a:ext uri="{FF2B5EF4-FFF2-40B4-BE49-F238E27FC236}">
                  <a16:creationId xmlns:a16="http://schemas.microsoft.com/office/drawing/2014/main" id="{D6E52837-9BE6-4E35-8433-6C76D051DDBF}"/>
                </a:ext>
              </a:extLst>
            </p:cNvPr>
            <p:cNvSpPr txBox="1"/>
            <p:nvPr/>
          </p:nvSpPr>
          <p:spPr>
            <a:xfrm>
              <a:off x="1393655" y="2126176"/>
              <a:ext cx="846780" cy="3162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en-IN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. </a:t>
              </a:r>
              <a:r>
                <a:rPr lang="en-IN" sz="1200" b="1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Fetuses</a:t>
              </a:r>
              <a:endPara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CA1B0C7-C59B-44B6-A858-4F7CE4BF0C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932" t="10064" r="1643" b="5426"/>
            <a:stretch/>
          </p:blipFill>
          <p:spPr>
            <a:xfrm rot="5400000">
              <a:off x="1540104" y="794063"/>
              <a:ext cx="1025353" cy="131825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C469B5F0-9CE8-424C-A2A6-8DEAD32645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43" t="15217" r="9113" b="3108"/>
            <a:stretch/>
          </p:blipFill>
          <p:spPr>
            <a:xfrm rot="5400000">
              <a:off x="2848576" y="847930"/>
              <a:ext cx="1062844" cy="128126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7CEBF66-D0F9-44ED-BA7B-F9F69961D63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35059" y="1683888"/>
              <a:ext cx="1937629" cy="1359989"/>
            </a:xfrm>
            <a:prstGeom prst="rect">
              <a:avLst/>
            </a:prstGeom>
          </p:spPr>
        </p:pic>
        <p:sp>
          <p:nvSpPr>
            <p:cNvPr id="7" name="TextBox 18">
              <a:extLst>
                <a:ext uri="{FF2B5EF4-FFF2-40B4-BE49-F238E27FC236}">
                  <a16:creationId xmlns:a16="http://schemas.microsoft.com/office/drawing/2014/main" id="{BAC1E8EA-3ABA-4209-A98E-26C8DEE50E4C}"/>
                </a:ext>
              </a:extLst>
            </p:cNvPr>
            <p:cNvSpPr txBox="1"/>
            <p:nvPr/>
          </p:nvSpPr>
          <p:spPr>
            <a:xfrm>
              <a:off x="4186694" y="1390807"/>
              <a:ext cx="208665" cy="3162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en-IN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9">
              <a:extLst>
                <a:ext uri="{FF2B5EF4-FFF2-40B4-BE49-F238E27FC236}">
                  <a16:creationId xmlns:a16="http://schemas.microsoft.com/office/drawing/2014/main" id="{AB1A9331-EF02-4256-A8B9-02DF1BFF13EE}"/>
                </a:ext>
              </a:extLst>
            </p:cNvPr>
            <p:cNvSpPr txBox="1"/>
            <p:nvPr/>
          </p:nvSpPr>
          <p:spPr>
            <a:xfrm>
              <a:off x="1741653" y="1903813"/>
              <a:ext cx="732818" cy="2964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en-IN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9">
              <a:extLst>
                <a:ext uri="{FF2B5EF4-FFF2-40B4-BE49-F238E27FC236}">
                  <a16:creationId xmlns:a16="http://schemas.microsoft.com/office/drawing/2014/main" id="{F87EC9A2-C3B2-480D-90CD-009A83F19158}"/>
                </a:ext>
              </a:extLst>
            </p:cNvPr>
            <p:cNvSpPr txBox="1"/>
            <p:nvPr/>
          </p:nvSpPr>
          <p:spPr>
            <a:xfrm>
              <a:off x="3096240" y="1902297"/>
              <a:ext cx="732818" cy="2964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en-IN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COS</a:t>
              </a:r>
              <a:endPara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9">
              <a:extLst>
                <a:ext uri="{FF2B5EF4-FFF2-40B4-BE49-F238E27FC236}">
                  <a16:creationId xmlns:a16="http://schemas.microsoft.com/office/drawing/2014/main" id="{494573E8-4B9E-4B6E-9CFC-C0B1AE3BF060}"/>
                </a:ext>
              </a:extLst>
            </p:cNvPr>
            <p:cNvSpPr txBox="1"/>
            <p:nvPr/>
          </p:nvSpPr>
          <p:spPr>
            <a:xfrm>
              <a:off x="1807382" y="3473738"/>
              <a:ext cx="732818" cy="2964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en-IN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9">
              <a:extLst>
                <a:ext uri="{FF2B5EF4-FFF2-40B4-BE49-F238E27FC236}">
                  <a16:creationId xmlns:a16="http://schemas.microsoft.com/office/drawing/2014/main" id="{4B9BD808-0269-4D91-B25A-0CF7A6D4411D}"/>
                </a:ext>
              </a:extLst>
            </p:cNvPr>
            <p:cNvSpPr txBox="1"/>
            <p:nvPr/>
          </p:nvSpPr>
          <p:spPr>
            <a:xfrm>
              <a:off x="3126046" y="3465184"/>
              <a:ext cx="732818" cy="2964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en-IN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COS</a:t>
              </a:r>
              <a:endPara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BCE6BA03-2252-4A66-9672-1D4AD48A4F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932" t="10064" r="1643" b="5426"/>
            <a:stretch/>
          </p:blipFill>
          <p:spPr>
            <a:xfrm rot="5400000">
              <a:off x="1513046" y="821125"/>
              <a:ext cx="1079469" cy="131825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D07A5D23-E6DB-45A2-9867-27AFADD226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932" t="10064" r="1643" b="5426"/>
            <a:stretch/>
          </p:blipFill>
          <p:spPr>
            <a:xfrm rot="5400000">
              <a:off x="1513046" y="821126"/>
              <a:ext cx="1079469" cy="131825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0777074D-91C6-4767-B690-5437C7DECE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932" t="10064" r="1643" b="5426"/>
            <a:stretch/>
          </p:blipFill>
          <p:spPr>
            <a:xfrm rot="5400000">
              <a:off x="1530371" y="830716"/>
              <a:ext cx="1063870" cy="1299200"/>
            </a:xfrm>
            <a:prstGeom prst="rect">
              <a:avLst/>
            </a:prstGeom>
          </p:spPr>
        </p:pic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78E38D87-F150-4218-8AB8-1A8832E1211F}"/>
              </a:ext>
            </a:extLst>
          </p:cNvPr>
          <p:cNvSpPr txBox="1"/>
          <p:nvPr/>
        </p:nvSpPr>
        <p:spPr>
          <a:xfrm>
            <a:off x="0" y="3776554"/>
            <a:ext cx="6858000" cy="15170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60325" algn="just">
              <a:lnSpc>
                <a:spcPct val="200000"/>
              </a:lnSpc>
              <a:spcAft>
                <a:spcPts val="800"/>
              </a:spcAft>
              <a:tabLst>
                <a:tab pos="4800600" algn="l"/>
              </a:tabLst>
            </a:pPr>
            <a:r>
              <a:rPr lang="en-IN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2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fect in </a:t>
            </a:r>
            <a:r>
              <a:rPr lang="en-IN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etal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rowth and development on the day 18</a:t>
            </a:r>
            <a:r>
              <a:rPr lang="en-IN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pregnancy in letrozole induced PCOS animals </a:t>
            </a:r>
            <a:r>
              <a:rPr lang="en-IN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IN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IN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terus with growing </a:t>
            </a:r>
            <a:r>
              <a:rPr lang="en-IN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etuses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IN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IN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etuses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he graph represents a number of fetus/pups delivered to the letrozole-induced PCOS mouse model. </a:t>
            </a:r>
            <a:r>
              <a:rPr lang="en-IN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ror bars represent SEM; N=6 per group. 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P&lt;0.01</a:t>
            </a:r>
            <a:r>
              <a:rPr lang="en-IN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s compared to the control group.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7879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0</TotalTime>
  <Words>85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17</cp:revision>
  <dcterms:created xsi:type="dcterms:W3CDTF">2022-04-15T09:53:27Z</dcterms:created>
  <dcterms:modified xsi:type="dcterms:W3CDTF">2022-04-24T14:09:55Z</dcterms:modified>
</cp:coreProperties>
</file>